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516"/>
    <p:restoredTop sz="94710"/>
  </p:normalViewPr>
  <p:slideViewPr>
    <p:cSldViewPr>
      <p:cViewPr>
        <p:scale>
          <a:sx n="66" d="100"/>
          <a:sy n="66" d="100"/>
        </p:scale>
        <p:origin x="1982" y="403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A191E7-FE41-4394-BEDD-DE3E7186FADC}" type="datetimeFigureOut">
              <a:rPr lang="es-ES" smtClean="0"/>
              <a:t>29/10/202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F3888-20E7-4080-8E3F-66DEC87B910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631336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A191E7-FE41-4394-BEDD-DE3E7186FADC}" type="datetimeFigureOut">
              <a:rPr lang="es-ES" smtClean="0"/>
              <a:t>29/10/202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F3888-20E7-4080-8E3F-66DEC87B910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283798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A191E7-FE41-4394-BEDD-DE3E7186FADC}" type="datetimeFigureOut">
              <a:rPr lang="es-ES" smtClean="0"/>
              <a:t>29/10/202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F3888-20E7-4080-8E3F-66DEC87B910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346959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A191E7-FE41-4394-BEDD-DE3E7186FADC}" type="datetimeFigureOut">
              <a:rPr lang="es-ES" smtClean="0"/>
              <a:t>29/10/202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F3888-20E7-4080-8E3F-66DEC87B910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469751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A191E7-FE41-4394-BEDD-DE3E7186FADC}" type="datetimeFigureOut">
              <a:rPr lang="es-ES" smtClean="0"/>
              <a:t>29/10/202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F3888-20E7-4080-8E3F-66DEC87B910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784882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A191E7-FE41-4394-BEDD-DE3E7186FADC}" type="datetimeFigureOut">
              <a:rPr lang="es-ES" smtClean="0"/>
              <a:t>29/10/2024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F3888-20E7-4080-8E3F-66DEC87B910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391808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A191E7-FE41-4394-BEDD-DE3E7186FADC}" type="datetimeFigureOut">
              <a:rPr lang="es-ES" smtClean="0"/>
              <a:t>29/10/2024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F3888-20E7-4080-8E3F-66DEC87B910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765090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A191E7-FE41-4394-BEDD-DE3E7186FADC}" type="datetimeFigureOut">
              <a:rPr lang="es-ES" smtClean="0"/>
              <a:t>29/10/2024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F3888-20E7-4080-8E3F-66DEC87B910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791442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A191E7-FE41-4394-BEDD-DE3E7186FADC}" type="datetimeFigureOut">
              <a:rPr lang="es-ES" smtClean="0"/>
              <a:t>29/10/2024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F3888-20E7-4080-8E3F-66DEC87B910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620045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A191E7-FE41-4394-BEDD-DE3E7186FADC}" type="datetimeFigureOut">
              <a:rPr lang="es-ES" smtClean="0"/>
              <a:t>29/10/2024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F3888-20E7-4080-8E3F-66DEC87B910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89085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A191E7-FE41-4394-BEDD-DE3E7186FADC}" type="datetimeFigureOut">
              <a:rPr lang="es-ES" smtClean="0"/>
              <a:t>29/10/2024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F3888-20E7-4080-8E3F-66DEC87B910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705380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A191E7-FE41-4394-BEDD-DE3E7186FADC}" type="datetimeFigureOut">
              <a:rPr lang="es-ES" smtClean="0"/>
              <a:t>29/10/202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0F3888-20E7-4080-8E3F-66DEC87B9103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695060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jpeg"/><Relationship Id="rId4" Type="http://schemas.openxmlformats.org/officeDocument/2006/relationships/image" Target="../media/image7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uadro de texto 1"/>
          <p:cNvSpPr txBox="1"/>
          <p:nvPr/>
        </p:nvSpPr>
        <p:spPr>
          <a:xfrm>
            <a:off x="1457325" y="5570852"/>
            <a:ext cx="6229350" cy="666460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</a:pPr>
            <a:r>
              <a:rPr lang="es-ES" sz="900" b="1" kern="100" dirty="0">
                <a:effectLst/>
                <a:latin typeface="Times New Roman"/>
                <a:ea typeface="Aptos"/>
                <a:cs typeface="Times New Roman"/>
              </a:rPr>
              <a:t>Table S1a. </a:t>
            </a:r>
            <a:r>
              <a:rPr lang="es-ES" sz="900" b="1" kern="100" dirty="0" err="1">
                <a:effectLst/>
                <a:latin typeface="Times New Roman"/>
                <a:ea typeface="Aptos"/>
                <a:cs typeface="Times New Roman"/>
              </a:rPr>
              <a:t>Clinical</a:t>
            </a:r>
            <a:r>
              <a:rPr lang="es-ES" sz="900" b="1" kern="100" dirty="0">
                <a:effectLst/>
                <a:latin typeface="Times New Roman"/>
                <a:ea typeface="Aptos"/>
                <a:cs typeface="Times New Roman"/>
              </a:rPr>
              <a:t> </a:t>
            </a:r>
            <a:r>
              <a:rPr lang="es-ES" sz="900" b="1" kern="100" dirty="0" err="1">
                <a:effectLst/>
                <a:latin typeface="Times New Roman"/>
                <a:ea typeface="Aptos"/>
                <a:cs typeface="Times New Roman"/>
              </a:rPr>
              <a:t>characteristics</a:t>
            </a:r>
            <a:r>
              <a:rPr lang="es-ES" sz="900" b="1" kern="100" dirty="0">
                <a:effectLst/>
                <a:latin typeface="Times New Roman"/>
                <a:ea typeface="Aptos"/>
                <a:cs typeface="Times New Roman"/>
              </a:rPr>
              <a:t> </a:t>
            </a:r>
            <a:r>
              <a:rPr lang="es-ES" sz="900" b="1" kern="100" dirty="0" err="1">
                <a:effectLst/>
                <a:latin typeface="Times New Roman"/>
                <a:ea typeface="Aptos"/>
                <a:cs typeface="Times New Roman"/>
              </a:rPr>
              <a:t>of</a:t>
            </a:r>
            <a:r>
              <a:rPr lang="es-ES" sz="900" b="1" kern="100" dirty="0">
                <a:effectLst/>
                <a:latin typeface="Times New Roman"/>
                <a:ea typeface="Aptos"/>
                <a:cs typeface="Times New Roman"/>
              </a:rPr>
              <a:t> TDT and NTDT </a:t>
            </a:r>
            <a:r>
              <a:rPr lang="es-ES" sz="900" b="1" kern="100" dirty="0" err="1">
                <a:effectLst/>
                <a:latin typeface="Times New Roman"/>
                <a:ea typeface="Aptos"/>
                <a:cs typeface="Times New Roman"/>
              </a:rPr>
              <a:t>patients</a:t>
            </a:r>
            <a:r>
              <a:rPr lang="es-ES" sz="900" b="1" kern="100" dirty="0">
                <a:effectLst/>
                <a:latin typeface="Times New Roman"/>
                <a:ea typeface="Aptos"/>
                <a:cs typeface="Times New Roman"/>
              </a:rPr>
              <a:t>.</a:t>
            </a:r>
          </a:p>
          <a:p>
            <a:pPr>
              <a:lnSpc>
                <a:spcPct val="115000"/>
              </a:lnSpc>
              <a:spcAft>
                <a:spcPts val="800"/>
              </a:spcAft>
            </a:pPr>
            <a:r>
              <a:rPr lang="es-ES" sz="900" b="1" kern="100" dirty="0">
                <a:latin typeface="Times New Roman"/>
                <a:ea typeface="Aptos"/>
                <a:cs typeface="Times New Roman"/>
              </a:rPr>
              <a:t>Normal </a:t>
            </a:r>
            <a:r>
              <a:rPr lang="es-ES" sz="900" b="1" kern="100" dirty="0" err="1">
                <a:latin typeface="Times New Roman"/>
                <a:ea typeface="Aptos"/>
                <a:cs typeface="Times New Roman"/>
              </a:rPr>
              <a:t>values</a:t>
            </a:r>
            <a:r>
              <a:rPr lang="es-ES" sz="900" b="1" kern="100" dirty="0">
                <a:latin typeface="Times New Roman"/>
                <a:ea typeface="Aptos"/>
                <a:cs typeface="Times New Roman"/>
              </a:rPr>
              <a:t>: </a:t>
            </a:r>
            <a:r>
              <a:rPr lang="es-ES" sz="900" kern="100" dirty="0" err="1">
                <a:latin typeface="Times New Roman"/>
                <a:ea typeface="Aptos"/>
                <a:cs typeface="Times New Roman"/>
              </a:rPr>
              <a:t>Bilirrubin</a:t>
            </a:r>
            <a:r>
              <a:rPr lang="es-ES" sz="900" kern="100" dirty="0">
                <a:latin typeface="Times New Roman"/>
                <a:ea typeface="Aptos"/>
                <a:cs typeface="Times New Roman"/>
              </a:rPr>
              <a:t> 0.05-1.2 mg/</a:t>
            </a:r>
            <a:r>
              <a:rPr lang="es-ES" sz="900" kern="100" dirty="0" err="1">
                <a:latin typeface="Times New Roman"/>
                <a:ea typeface="Aptos"/>
                <a:cs typeface="Times New Roman"/>
              </a:rPr>
              <a:t>dL</a:t>
            </a:r>
            <a:r>
              <a:rPr lang="es-ES" sz="900" kern="100" dirty="0">
                <a:latin typeface="Times New Roman"/>
                <a:ea typeface="Aptos"/>
                <a:cs typeface="Times New Roman"/>
              </a:rPr>
              <a:t>, LDH 135-214 UI/L, EPO 5-30 </a:t>
            </a:r>
            <a:r>
              <a:rPr lang="es-ES" sz="900" kern="100" dirty="0" err="1">
                <a:latin typeface="Times New Roman"/>
                <a:ea typeface="Aptos"/>
                <a:cs typeface="Times New Roman"/>
              </a:rPr>
              <a:t>mU</a:t>
            </a:r>
            <a:r>
              <a:rPr lang="es-ES" sz="900" kern="100" dirty="0">
                <a:latin typeface="Times New Roman"/>
                <a:ea typeface="Aptos"/>
                <a:cs typeface="Times New Roman"/>
              </a:rPr>
              <a:t>/ml, RST 0.8-1.8 mg/L, </a:t>
            </a:r>
            <a:r>
              <a:rPr lang="es-ES" sz="900" kern="100" dirty="0" err="1">
                <a:latin typeface="Times New Roman"/>
                <a:ea typeface="Aptos"/>
                <a:cs typeface="Times New Roman"/>
              </a:rPr>
              <a:t>hemoglobin</a:t>
            </a:r>
            <a:r>
              <a:rPr lang="es-ES" sz="900" kern="100" dirty="0">
                <a:latin typeface="Times New Roman"/>
                <a:ea typeface="Aptos"/>
                <a:cs typeface="Times New Roman"/>
              </a:rPr>
              <a:t> 13.5-17.5 g/</a:t>
            </a:r>
            <a:r>
              <a:rPr lang="es-ES" sz="900" kern="100" dirty="0" err="1">
                <a:latin typeface="Times New Roman"/>
                <a:ea typeface="Aptos"/>
                <a:cs typeface="Times New Roman"/>
              </a:rPr>
              <a:t>dL</a:t>
            </a:r>
            <a:r>
              <a:rPr lang="es-ES" sz="900" kern="100" dirty="0">
                <a:latin typeface="Times New Roman"/>
                <a:ea typeface="Aptos"/>
                <a:cs typeface="Times New Roman"/>
              </a:rPr>
              <a:t> (male) 12-16 g/</a:t>
            </a:r>
            <a:r>
              <a:rPr lang="es-ES" sz="900" kern="100" dirty="0" err="1">
                <a:latin typeface="Times New Roman"/>
                <a:ea typeface="Aptos"/>
                <a:cs typeface="Times New Roman"/>
              </a:rPr>
              <a:t>dL</a:t>
            </a:r>
            <a:r>
              <a:rPr lang="es-ES" sz="900" kern="100" dirty="0">
                <a:latin typeface="Times New Roman"/>
                <a:ea typeface="Aptos"/>
                <a:cs typeface="Times New Roman"/>
              </a:rPr>
              <a:t> (</a:t>
            </a:r>
            <a:r>
              <a:rPr lang="es-ES" sz="900" kern="100" dirty="0" err="1">
                <a:latin typeface="Times New Roman"/>
                <a:ea typeface="Aptos"/>
                <a:cs typeface="Times New Roman"/>
              </a:rPr>
              <a:t>female</a:t>
            </a:r>
            <a:r>
              <a:rPr lang="es-ES" sz="900" kern="100" dirty="0">
                <a:latin typeface="Times New Roman"/>
                <a:ea typeface="Aptos"/>
                <a:cs typeface="Times New Roman"/>
              </a:rPr>
              <a:t>), </a:t>
            </a:r>
            <a:r>
              <a:rPr lang="es-ES" sz="900" kern="100" dirty="0" err="1">
                <a:latin typeface="Times New Roman"/>
                <a:ea typeface="Aptos"/>
                <a:cs typeface="Times New Roman"/>
              </a:rPr>
              <a:t>reticulocytes</a:t>
            </a:r>
            <a:r>
              <a:rPr lang="es-ES" sz="900" kern="100" dirty="0">
                <a:latin typeface="Times New Roman"/>
                <a:ea typeface="Aptos"/>
                <a:cs typeface="Times New Roman"/>
              </a:rPr>
              <a:t> 35000-75000/L, </a:t>
            </a:r>
            <a:r>
              <a:rPr lang="es-ES" sz="900" kern="100" dirty="0" err="1">
                <a:latin typeface="Times New Roman"/>
                <a:ea typeface="Aptos"/>
                <a:cs typeface="Times New Roman"/>
              </a:rPr>
              <a:t>ferritin</a:t>
            </a:r>
            <a:r>
              <a:rPr lang="es-ES" sz="900" kern="100" dirty="0">
                <a:latin typeface="Times New Roman"/>
                <a:ea typeface="Aptos"/>
                <a:cs typeface="Times New Roman"/>
              </a:rPr>
              <a:t> </a:t>
            </a:r>
            <a:r>
              <a:rPr lang="es-ES" sz="900" kern="100" dirty="0">
                <a:latin typeface="Times New Roman" panose="02020603050405020304" pitchFamily="18" charset="0"/>
                <a:ea typeface="Aptos"/>
                <a:cs typeface="Times New Roman" panose="02020603050405020304" pitchFamily="18" charset="0"/>
              </a:rPr>
              <a:t>3</a:t>
            </a:r>
            <a:r>
              <a:rPr lang="es-ES" sz="9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-400 </a:t>
            </a:r>
            <a:r>
              <a:rPr lang="es-ES" sz="900" kern="100" dirty="0">
                <a:latin typeface="Times New Roman"/>
                <a:ea typeface="Aptos"/>
                <a:cs typeface="Times New Roman"/>
              </a:rPr>
              <a:t>ng/ml, IST 24-40%</a:t>
            </a:r>
            <a:endParaRPr lang="es-ES" sz="1200" kern="100" dirty="0">
              <a:effectLst/>
              <a:latin typeface="Aptos"/>
              <a:ea typeface="Aptos"/>
              <a:cs typeface="Times New Roman"/>
            </a:endParaRPr>
          </a:p>
          <a:p>
            <a:pPr>
              <a:lnSpc>
                <a:spcPct val="115000"/>
              </a:lnSpc>
              <a:spcAft>
                <a:spcPts val="800"/>
              </a:spcAft>
            </a:pPr>
            <a:r>
              <a:rPr lang="es-ES" sz="900" b="1" kern="100" dirty="0">
                <a:effectLst/>
                <a:latin typeface="Times New Roman"/>
                <a:ea typeface="Aptos"/>
                <a:cs typeface="Times New Roman"/>
              </a:rPr>
              <a:t> </a:t>
            </a:r>
            <a:endParaRPr lang="es-ES" sz="1200" kern="100" dirty="0">
              <a:effectLst/>
              <a:latin typeface="Aptos"/>
              <a:ea typeface="Aptos"/>
              <a:cs typeface="Times New Roman"/>
            </a:endParaRPr>
          </a:p>
        </p:txBody>
      </p:sp>
      <p:pic>
        <p:nvPicPr>
          <p:cNvPr id="3" name="Imagen 2" descr="Una captura de pantalla de un celular con letras&#10;&#10;Descripción generada automáticamente con confianza media">
            <a:extLst>
              <a:ext uri="{FF2B5EF4-FFF2-40B4-BE49-F238E27FC236}">
                <a16:creationId xmlns:a16="http://schemas.microsoft.com/office/drawing/2014/main" id="{BBC972A3-BD9A-B774-8C35-24D6F3D6D39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7325" y="442590"/>
            <a:ext cx="5735414" cy="51282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944142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uadro de texto 1"/>
          <p:cNvSpPr txBox="1"/>
          <p:nvPr/>
        </p:nvSpPr>
        <p:spPr>
          <a:xfrm>
            <a:off x="755576" y="5123242"/>
            <a:ext cx="5172075" cy="458671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</a:pPr>
            <a:r>
              <a:rPr lang="es-ES" sz="900" b="1" kern="100" dirty="0">
                <a:effectLst/>
                <a:latin typeface="Times New Roman"/>
                <a:ea typeface="Aptos"/>
                <a:cs typeface="Times New Roman"/>
              </a:rPr>
              <a:t>Table S1b. </a:t>
            </a:r>
            <a:r>
              <a:rPr lang="es-ES" sz="900" b="1" kern="100" dirty="0" err="1">
                <a:effectLst/>
                <a:latin typeface="Times New Roman"/>
                <a:ea typeface="Aptos"/>
                <a:cs typeface="Times New Roman"/>
              </a:rPr>
              <a:t>Phenotype-genotype</a:t>
            </a:r>
            <a:r>
              <a:rPr lang="es-ES" sz="900" b="1" kern="100" dirty="0">
                <a:effectLst/>
                <a:latin typeface="Times New Roman"/>
                <a:ea typeface="Aptos"/>
                <a:cs typeface="Times New Roman"/>
              </a:rPr>
              <a:t> </a:t>
            </a:r>
            <a:r>
              <a:rPr lang="es-ES" sz="900" b="1" kern="100" dirty="0" err="1">
                <a:effectLst/>
                <a:latin typeface="Times New Roman"/>
                <a:ea typeface="Aptos"/>
                <a:cs typeface="Times New Roman"/>
              </a:rPr>
              <a:t>correlation</a:t>
            </a:r>
            <a:r>
              <a:rPr lang="es-ES" sz="900" b="1" kern="100" dirty="0">
                <a:effectLst/>
                <a:latin typeface="Times New Roman"/>
                <a:ea typeface="Aptos"/>
                <a:cs typeface="Times New Roman"/>
              </a:rPr>
              <a:t> in </a:t>
            </a:r>
            <a:r>
              <a:rPr lang="es-ES" sz="900" b="1" kern="100" dirty="0" err="1">
                <a:effectLst/>
                <a:latin typeface="Times New Roman"/>
                <a:ea typeface="Aptos"/>
                <a:cs typeface="Times New Roman"/>
              </a:rPr>
              <a:t>thalassemic</a:t>
            </a:r>
            <a:r>
              <a:rPr lang="es-ES" sz="900" b="1" kern="100" dirty="0">
                <a:effectLst/>
                <a:latin typeface="Times New Roman"/>
                <a:ea typeface="Aptos"/>
                <a:cs typeface="Times New Roman"/>
              </a:rPr>
              <a:t> </a:t>
            </a:r>
            <a:r>
              <a:rPr lang="es-ES" sz="900" b="1" kern="100" dirty="0" err="1">
                <a:effectLst/>
                <a:latin typeface="Times New Roman"/>
                <a:ea typeface="Aptos"/>
                <a:cs typeface="Times New Roman"/>
              </a:rPr>
              <a:t>patients</a:t>
            </a:r>
            <a:r>
              <a:rPr lang="es-ES" sz="900" b="1" kern="100" dirty="0">
                <a:effectLst/>
                <a:latin typeface="Times New Roman"/>
                <a:ea typeface="Aptos"/>
                <a:cs typeface="Times New Roman"/>
              </a:rPr>
              <a:t>.</a:t>
            </a:r>
            <a:endParaRPr lang="es-ES" sz="1200" kern="100" dirty="0">
              <a:effectLst/>
              <a:latin typeface="Aptos"/>
              <a:ea typeface="Aptos"/>
              <a:cs typeface="Times New Roman"/>
            </a:endParaRPr>
          </a:p>
          <a:p>
            <a:pPr>
              <a:lnSpc>
                <a:spcPct val="115000"/>
              </a:lnSpc>
              <a:spcAft>
                <a:spcPts val="800"/>
              </a:spcAft>
            </a:pPr>
            <a:r>
              <a:rPr lang="es-ES" sz="900" b="1" kern="100" dirty="0">
                <a:effectLst/>
                <a:latin typeface="Times New Roman"/>
                <a:ea typeface="Aptos"/>
                <a:cs typeface="Times New Roman"/>
              </a:rPr>
              <a:t> </a:t>
            </a:r>
            <a:endParaRPr lang="es-ES" sz="1200" kern="100" dirty="0">
              <a:effectLst/>
              <a:latin typeface="Aptos"/>
              <a:ea typeface="Aptos"/>
              <a:cs typeface="Times New Roman"/>
            </a:endParaRPr>
          </a:p>
        </p:txBody>
      </p:sp>
      <p:pic>
        <p:nvPicPr>
          <p:cNvPr id="3" name="Imagen 2" descr="Tabla&#10;&#10;Descripción generada automáticamente">
            <a:extLst>
              <a:ext uri="{FF2B5EF4-FFF2-40B4-BE49-F238E27FC236}">
                <a16:creationId xmlns:a16="http://schemas.microsoft.com/office/drawing/2014/main" id="{1E3B4E0B-7CD0-FED2-DE6C-2641ED93DFC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1560" y="1098121"/>
            <a:ext cx="7772400" cy="40155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8566087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 descr="C:\Users\quita\OneDrive\Escritorio\tabla 2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7021" y="1268760"/>
            <a:ext cx="6733108" cy="245157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Cuadro de texto 1"/>
          <p:cNvSpPr txBox="1"/>
          <p:nvPr/>
        </p:nvSpPr>
        <p:spPr>
          <a:xfrm>
            <a:off x="917021" y="3839266"/>
            <a:ext cx="6733108" cy="741862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</a:pPr>
            <a:r>
              <a:rPr lang="es-ES" sz="900" b="1" kern="100" dirty="0">
                <a:effectLst/>
                <a:latin typeface="Times New Roman"/>
                <a:ea typeface="Aptos"/>
                <a:cs typeface="Times New Roman"/>
              </a:rPr>
              <a:t>Table S2. </a:t>
            </a:r>
            <a:r>
              <a:rPr lang="es-ES" sz="900" b="1" kern="100" dirty="0" err="1">
                <a:effectLst/>
                <a:latin typeface="Times New Roman"/>
                <a:ea typeface="Aptos"/>
                <a:cs typeface="Times New Roman"/>
              </a:rPr>
              <a:t>Clinical</a:t>
            </a:r>
            <a:r>
              <a:rPr lang="es-ES" sz="900" b="1" kern="100" dirty="0">
                <a:effectLst/>
                <a:latin typeface="Times New Roman"/>
                <a:ea typeface="Aptos"/>
                <a:cs typeface="Times New Roman"/>
              </a:rPr>
              <a:t> </a:t>
            </a:r>
            <a:r>
              <a:rPr lang="es-ES" sz="900" b="1" kern="100" dirty="0" err="1">
                <a:effectLst/>
                <a:latin typeface="Times New Roman"/>
                <a:ea typeface="Aptos"/>
                <a:cs typeface="Times New Roman"/>
              </a:rPr>
              <a:t>characteristics</a:t>
            </a:r>
            <a:r>
              <a:rPr lang="es-ES" sz="900" b="1" kern="100" dirty="0">
                <a:effectLst/>
                <a:latin typeface="Times New Roman"/>
                <a:ea typeface="Aptos"/>
                <a:cs typeface="Times New Roman"/>
              </a:rPr>
              <a:t> </a:t>
            </a:r>
            <a:r>
              <a:rPr lang="es-ES" sz="900" b="1" kern="100" dirty="0" err="1">
                <a:effectLst/>
                <a:latin typeface="Times New Roman"/>
                <a:ea typeface="Aptos"/>
                <a:cs typeface="Times New Roman"/>
              </a:rPr>
              <a:t>of</a:t>
            </a:r>
            <a:r>
              <a:rPr lang="es-ES" sz="900" b="1" kern="100" dirty="0">
                <a:effectLst/>
                <a:latin typeface="Times New Roman"/>
                <a:ea typeface="Aptos"/>
                <a:cs typeface="Times New Roman"/>
              </a:rPr>
              <a:t>  </a:t>
            </a:r>
            <a:r>
              <a:rPr lang="es-ES" sz="900" b="1" kern="100" dirty="0">
                <a:latin typeface="Times New Roman"/>
                <a:ea typeface="Aptos"/>
                <a:cs typeface="Times New Roman"/>
              </a:rPr>
              <a:t>SCD </a:t>
            </a:r>
            <a:r>
              <a:rPr lang="es-ES" sz="900" b="1" kern="100" dirty="0" err="1">
                <a:effectLst/>
                <a:latin typeface="Times New Roman"/>
                <a:ea typeface="Aptos"/>
                <a:cs typeface="Times New Roman"/>
              </a:rPr>
              <a:t>patients</a:t>
            </a:r>
            <a:endParaRPr lang="es-ES" sz="900" b="1" kern="100" dirty="0">
              <a:effectLst/>
              <a:latin typeface="Times New Roman"/>
              <a:ea typeface="Aptos"/>
              <a:cs typeface="Times New Roman"/>
            </a:endParaRPr>
          </a:p>
          <a:p>
            <a:pPr>
              <a:lnSpc>
                <a:spcPct val="115000"/>
              </a:lnSpc>
              <a:spcAft>
                <a:spcPts val="800"/>
              </a:spcAft>
            </a:pPr>
            <a:r>
              <a:rPr lang="es-ES" sz="900" b="1" kern="100" dirty="0">
                <a:latin typeface="Times New Roman"/>
                <a:ea typeface="Aptos"/>
                <a:cs typeface="Times New Roman"/>
              </a:rPr>
              <a:t>Normal </a:t>
            </a:r>
            <a:r>
              <a:rPr lang="es-ES" sz="900" b="1" kern="100" dirty="0" err="1">
                <a:latin typeface="Times New Roman"/>
                <a:ea typeface="Aptos"/>
                <a:cs typeface="Times New Roman"/>
              </a:rPr>
              <a:t>values</a:t>
            </a:r>
            <a:r>
              <a:rPr lang="es-ES" sz="900" b="1" kern="100" dirty="0">
                <a:latin typeface="Times New Roman"/>
                <a:ea typeface="Aptos"/>
                <a:cs typeface="Times New Roman"/>
              </a:rPr>
              <a:t>: </a:t>
            </a:r>
            <a:r>
              <a:rPr lang="es-ES" sz="900" kern="100" dirty="0" err="1">
                <a:latin typeface="Times New Roman"/>
                <a:ea typeface="Aptos"/>
                <a:cs typeface="Times New Roman"/>
              </a:rPr>
              <a:t>Hemoglobin</a:t>
            </a:r>
            <a:r>
              <a:rPr lang="es-ES" sz="900" kern="100" dirty="0">
                <a:latin typeface="Times New Roman"/>
                <a:ea typeface="Aptos"/>
                <a:cs typeface="Times New Roman"/>
              </a:rPr>
              <a:t> 13.5-17.5 g/</a:t>
            </a:r>
            <a:r>
              <a:rPr lang="es-ES" sz="900" kern="100" dirty="0" err="1">
                <a:latin typeface="Times New Roman"/>
                <a:ea typeface="Aptos"/>
                <a:cs typeface="Times New Roman"/>
              </a:rPr>
              <a:t>dL</a:t>
            </a:r>
            <a:r>
              <a:rPr lang="es-ES" sz="900" kern="100" dirty="0">
                <a:latin typeface="Times New Roman"/>
                <a:ea typeface="Aptos"/>
                <a:cs typeface="Times New Roman"/>
              </a:rPr>
              <a:t> (male) 12-16 g/</a:t>
            </a:r>
            <a:r>
              <a:rPr lang="es-ES" sz="900" kern="100" dirty="0" err="1">
                <a:latin typeface="Times New Roman"/>
                <a:ea typeface="Aptos"/>
                <a:cs typeface="Times New Roman"/>
              </a:rPr>
              <a:t>dL</a:t>
            </a:r>
            <a:r>
              <a:rPr lang="es-ES" sz="900" kern="100" dirty="0">
                <a:latin typeface="Times New Roman"/>
                <a:ea typeface="Aptos"/>
                <a:cs typeface="Times New Roman"/>
              </a:rPr>
              <a:t> (</a:t>
            </a:r>
            <a:r>
              <a:rPr lang="es-ES" sz="900" kern="100" dirty="0" err="1">
                <a:latin typeface="Times New Roman"/>
                <a:ea typeface="Aptos"/>
                <a:cs typeface="Times New Roman"/>
              </a:rPr>
              <a:t>female</a:t>
            </a:r>
            <a:r>
              <a:rPr lang="es-ES" sz="900" kern="100" dirty="0">
                <a:latin typeface="Times New Roman"/>
                <a:ea typeface="Aptos"/>
                <a:cs typeface="Times New Roman"/>
              </a:rPr>
              <a:t>), </a:t>
            </a:r>
            <a:r>
              <a:rPr lang="es-ES" sz="900" kern="100" dirty="0" err="1">
                <a:latin typeface="Times New Roman"/>
                <a:ea typeface="Aptos"/>
                <a:cs typeface="Times New Roman"/>
              </a:rPr>
              <a:t>reticulocytes</a:t>
            </a:r>
            <a:r>
              <a:rPr lang="es-ES" sz="900" kern="100" dirty="0">
                <a:latin typeface="Times New Roman"/>
                <a:ea typeface="Aptos"/>
                <a:cs typeface="Times New Roman"/>
              </a:rPr>
              <a:t>  35000-75000/L, </a:t>
            </a:r>
            <a:r>
              <a:rPr lang="es-ES" sz="900" kern="100" dirty="0" err="1">
                <a:latin typeface="Times New Roman"/>
                <a:ea typeface="Aptos"/>
                <a:cs typeface="Times New Roman"/>
              </a:rPr>
              <a:t>ferritin</a:t>
            </a:r>
            <a:r>
              <a:rPr lang="es-ES" sz="900" kern="100" dirty="0">
                <a:latin typeface="Times New Roman"/>
                <a:ea typeface="Aptos"/>
                <a:cs typeface="Times New Roman"/>
              </a:rPr>
              <a:t> </a:t>
            </a:r>
            <a:r>
              <a:rPr lang="es-ES" sz="900" kern="100" dirty="0">
                <a:latin typeface="Times New Roman" panose="02020603050405020304" pitchFamily="18" charset="0"/>
                <a:ea typeface="Aptos"/>
                <a:cs typeface="Times New Roman" panose="02020603050405020304" pitchFamily="18" charset="0"/>
              </a:rPr>
              <a:t>3</a:t>
            </a:r>
            <a:r>
              <a:rPr lang="es-ES" sz="9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-400 </a:t>
            </a:r>
            <a:r>
              <a:rPr lang="es-ES" sz="900" kern="100" dirty="0">
                <a:latin typeface="Times New Roman"/>
                <a:ea typeface="Aptos"/>
                <a:cs typeface="Times New Roman"/>
              </a:rPr>
              <a:t>ng/ml, IST 24-40%, LDH 135-214 UI/L </a:t>
            </a:r>
            <a:endParaRPr lang="es-ES" sz="1200" kern="100" dirty="0">
              <a:effectLst/>
              <a:latin typeface="Aptos"/>
              <a:ea typeface="Aptos"/>
              <a:cs typeface="Times New Roman"/>
            </a:endParaRPr>
          </a:p>
          <a:p>
            <a:pPr>
              <a:lnSpc>
                <a:spcPct val="115000"/>
              </a:lnSpc>
              <a:spcAft>
                <a:spcPts val="800"/>
              </a:spcAft>
            </a:pPr>
            <a:r>
              <a:rPr lang="es-ES" sz="900" b="1" kern="100" dirty="0">
                <a:effectLst/>
                <a:latin typeface="Times New Roman"/>
                <a:ea typeface="Aptos"/>
                <a:cs typeface="Times New Roman"/>
              </a:rPr>
              <a:t> </a:t>
            </a:r>
            <a:endParaRPr lang="es-ES" sz="1200" kern="100" dirty="0">
              <a:effectLst/>
              <a:latin typeface="Aptos"/>
              <a:ea typeface="Aptos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84110698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 descr="C:\Users\quita\OneDrive\Escritorio\tabla 3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87624" y="620688"/>
            <a:ext cx="6950254" cy="426005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Cuadro de texto 1"/>
          <p:cNvSpPr txBox="1"/>
          <p:nvPr/>
        </p:nvSpPr>
        <p:spPr>
          <a:xfrm>
            <a:off x="1187624" y="4987308"/>
            <a:ext cx="7128792" cy="745948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</a:pPr>
            <a:r>
              <a:rPr lang="es-ES" sz="900" b="1" kern="100" dirty="0">
                <a:effectLst/>
                <a:latin typeface="Times New Roman"/>
                <a:ea typeface="Aptos"/>
                <a:cs typeface="Times New Roman"/>
              </a:rPr>
              <a:t>Table S3. </a:t>
            </a:r>
            <a:r>
              <a:rPr lang="es-ES" sz="900" b="1" kern="100" dirty="0" err="1">
                <a:effectLst/>
                <a:latin typeface="Times New Roman"/>
                <a:ea typeface="Aptos"/>
                <a:cs typeface="Times New Roman"/>
              </a:rPr>
              <a:t>Clinical</a:t>
            </a:r>
            <a:r>
              <a:rPr lang="es-ES" sz="900" b="1" kern="100" dirty="0">
                <a:effectLst/>
                <a:latin typeface="Times New Roman"/>
                <a:ea typeface="Aptos"/>
                <a:cs typeface="Times New Roman"/>
              </a:rPr>
              <a:t> </a:t>
            </a:r>
            <a:r>
              <a:rPr lang="es-ES" sz="900" b="1" kern="100" dirty="0" err="1">
                <a:effectLst/>
                <a:latin typeface="Times New Roman"/>
                <a:ea typeface="Aptos"/>
                <a:cs typeface="Times New Roman"/>
              </a:rPr>
              <a:t>characteristics</a:t>
            </a:r>
            <a:r>
              <a:rPr lang="es-ES" sz="900" b="1" kern="100" dirty="0">
                <a:effectLst/>
                <a:latin typeface="Times New Roman"/>
                <a:ea typeface="Aptos"/>
                <a:cs typeface="Times New Roman"/>
              </a:rPr>
              <a:t> of </a:t>
            </a:r>
            <a:r>
              <a:rPr lang="es-ES" sz="900" b="1" kern="100" dirty="0">
                <a:latin typeface="Times New Roman"/>
                <a:ea typeface="Aptos"/>
                <a:cs typeface="Times New Roman"/>
              </a:rPr>
              <a:t>CSA </a:t>
            </a:r>
            <a:r>
              <a:rPr lang="es-ES" sz="900" b="1" kern="100" dirty="0" err="1">
                <a:effectLst/>
                <a:latin typeface="Times New Roman"/>
                <a:ea typeface="Aptos"/>
                <a:cs typeface="Times New Roman"/>
              </a:rPr>
              <a:t>patient</a:t>
            </a:r>
            <a:r>
              <a:rPr lang="es-ES" sz="900" b="1" kern="100" dirty="0">
                <a:effectLst/>
                <a:latin typeface="Times New Roman"/>
                <a:ea typeface="Aptos"/>
                <a:cs typeface="Times New Roman"/>
              </a:rPr>
              <a:t>.</a:t>
            </a:r>
          </a:p>
          <a:p>
            <a:pPr>
              <a:lnSpc>
                <a:spcPct val="115000"/>
              </a:lnSpc>
              <a:spcAft>
                <a:spcPts val="800"/>
              </a:spcAft>
            </a:pPr>
            <a:r>
              <a:rPr lang="es-ES" sz="900" b="1" kern="100" dirty="0">
                <a:latin typeface="Times New Roman"/>
                <a:ea typeface="Aptos"/>
                <a:cs typeface="Times New Roman"/>
              </a:rPr>
              <a:t>Normal </a:t>
            </a:r>
            <a:r>
              <a:rPr lang="es-ES" sz="900" b="1" kern="100" dirty="0" err="1">
                <a:latin typeface="Times New Roman"/>
                <a:ea typeface="Aptos"/>
                <a:cs typeface="Times New Roman"/>
              </a:rPr>
              <a:t>values</a:t>
            </a:r>
            <a:r>
              <a:rPr lang="es-ES" sz="900" b="1" kern="100" dirty="0">
                <a:latin typeface="Times New Roman"/>
                <a:ea typeface="Aptos"/>
                <a:cs typeface="Times New Roman"/>
              </a:rPr>
              <a:t>: </a:t>
            </a:r>
            <a:r>
              <a:rPr lang="es-ES" sz="900" kern="100" dirty="0" err="1">
                <a:latin typeface="Times New Roman"/>
                <a:ea typeface="Aptos"/>
                <a:cs typeface="Times New Roman"/>
              </a:rPr>
              <a:t>Vitamin</a:t>
            </a:r>
            <a:r>
              <a:rPr lang="es-ES" sz="900" kern="100" dirty="0">
                <a:latin typeface="Times New Roman"/>
                <a:ea typeface="Aptos"/>
                <a:cs typeface="Times New Roman"/>
              </a:rPr>
              <a:t> D 20ug/L</a:t>
            </a:r>
            <a:r>
              <a:rPr lang="es-ES" sz="900" b="1" kern="100" dirty="0">
                <a:latin typeface="Times New Roman"/>
                <a:ea typeface="Aptos"/>
                <a:cs typeface="Times New Roman"/>
              </a:rPr>
              <a:t>, </a:t>
            </a:r>
            <a:r>
              <a:rPr lang="es-ES" sz="900" kern="100" dirty="0">
                <a:latin typeface="Times New Roman"/>
                <a:ea typeface="Aptos"/>
                <a:cs typeface="Times New Roman"/>
              </a:rPr>
              <a:t>PTH 10-55 </a:t>
            </a:r>
            <a:r>
              <a:rPr lang="es-ES" sz="900" kern="100" dirty="0" err="1">
                <a:latin typeface="Times New Roman"/>
                <a:ea typeface="Aptos"/>
                <a:cs typeface="Times New Roman"/>
              </a:rPr>
              <a:t>pg</a:t>
            </a:r>
            <a:r>
              <a:rPr lang="es-ES" sz="900" kern="100" dirty="0">
                <a:latin typeface="Times New Roman"/>
                <a:ea typeface="Aptos"/>
                <a:cs typeface="Times New Roman"/>
              </a:rPr>
              <a:t>/ml</a:t>
            </a:r>
            <a:r>
              <a:rPr lang="es-ES" sz="900" b="1" kern="100" dirty="0">
                <a:latin typeface="Times New Roman"/>
                <a:ea typeface="Aptos"/>
                <a:cs typeface="Times New Roman"/>
              </a:rPr>
              <a:t>, </a:t>
            </a:r>
            <a:r>
              <a:rPr lang="es-ES" sz="900" kern="100" dirty="0">
                <a:latin typeface="Times New Roman"/>
                <a:ea typeface="Aptos"/>
                <a:cs typeface="Times New Roman"/>
              </a:rPr>
              <a:t>Ca 8.6-10 mg/</a:t>
            </a:r>
            <a:r>
              <a:rPr lang="es-ES" sz="900" kern="100" dirty="0" err="1">
                <a:latin typeface="Times New Roman"/>
                <a:ea typeface="Aptos"/>
                <a:cs typeface="Times New Roman"/>
              </a:rPr>
              <a:t>dL</a:t>
            </a:r>
            <a:r>
              <a:rPr lang="es-ES" sz="900" kern="100" dirty="0">
                <a:latin typeface="Times New Roman"/>
                <a:ea typeface="Aptos"/>
                <a:cs typeface="Times New Roman"/>
              </a:rPr>
              <a:t>, P 2.5-4.5 mg/</a:t>
            </a:r>
            <a:r>
              <a:rPr lang="es-ES" sz="900" kern="100" dirty="0" err="1">
                <a:latin typeface="Times New Roman"/>
                <a:ea typeface="Aptos"/>
                <a:cs typeface="Times New Roman"/>
              </a:rPr>
              <a:t>dL</a:t>
            </a:r>
            <a:r>
              <a:rPr lang="es-ES" sz="900" b="1" kern="100" dirty="0">
                <a:latin typeface="Times New Roman"/>
                <a:ea typeface="Aptos"/>
                <a:cs typeface="Times New Roman"/>
              </a:rPr>
              <a:t>, </a:t>
            </a:r>
            <a:r>
              <a:rPr lang="es-ES" sz="900" kern="100" dirty="0" err="1">
                <a:latin typeface="Times New Roman"/>
                <a:ea typeface="Aptos"/>
                <a:cs typeface="Times New Roman"/>
              </a:rPr>
              <a:t>hemoglobin</a:t>
            </a:r>
            <a:r>
              <a:rPr lang="es-ES" sz="900" kern="100" dirty="0">
                <a:latin typeface="Times New Roman"/>
                <a:ea typeface="Aptos"/>
                <a:cs typeface="Times New Roman"/>
              </a:rPr>
              <a:t> 13.5-17.5 g/</a:t>
            </a:r>
            <a:r>
              <a:rPr lang="es-ES" sz="900" kern="100" dirty="0" err="1">
                <a:latin typeface="Times New Roman"/>
                <a:ea typeface="Aptos"/>
                <a:cs typeface="Times New Roman"/>
              </a:rPr>
              <a:t>dL</a:t>
            </a:r>
            <a:r>
              <a:rPr lang="es-ES" sz="900" kern="100" dirty="0">
                <a:latin typeface="Times New Roman"/>
                <a:ea typeface="Aptos"/>
                <a:cs typeface="Times New Roman"/>
              </a:rPr>
              <a:t>, VCM 80-100fL,  </a:t>
            </a:r>
            <a:r>
              <a:rPr lang="es-ES" sz="900" kern="100" dirty="0" err="1">
                <a:latin typeface="Times New Roman"/>
                <a:ea typeface="Aptos"/>
                <a:cs typeface="Times New Roman"/>
              </a:rPr>
              <a:t>reticulocytes</a:t>
            </a:r>
            <a:r>
              <a:rPr lang="es-ES" sz="900" kern="100" dirty="0">
                <a:latin typeface="Times New Roman"/>
                <a:ea typeface="Aptos"/>
                <a:cs typeface="Times New Roman"/>
              </a:rPr>
              <a:t> 35000-75000/L, EPO 5-30mU/ml, </a:t>
            </a:r>
            <a:r>
              <a:rPr lang="es-ES" sz="900" kern="100" dirty="0" err="1">
                <a:latin typeface="Times New Roman"/>
                <a:ea typeface="Aptos"/>
                <a:cs typeface="Times New Roman"/>
              </a:rPr>
              <a:t>iron</a:t>
            </a:r>
            <a:r>
              <a:rPr lang="es-ES" sz="900" kern="100" dirty="0">
                <a:latin typeface="Times New Roman"/>
                <a:ea typeface="Aptos"/>
                <a:cs typeface="Times New Roman"/>
              </a:rPr>
              <a:t> 37-145 </a:t>
            </a:r>
            <a:r>
              <a:rPr lang="es-ES" sz="900" kern="100" dirty="0" err="1">
                <a:latin typeface="Times New Roman"/>
                <a:ea typeface="Aptos"/>
                <a:cs typeface="Times New Roman"/>
              </a:rPr>
              <a:t>ug</a:t>
            </a:r>
            <a:r>
              <a:rPr lang="es-ES" sz="900" kern="100" dirty="0">
                <a:latin typeface="Times New Roman"/>
                <a:ea typeface="Aptos"/>
                <a:cs typeface="Times New Roman"/>
              </a:rPr>
              <a:t>/</a:t>
            </a:r>
            <a:r>
              <a:rPr lang="es-ES" sz="900" kern="100" dirty="0" err="1">
                <a:latin typeface="Times New Roman"/>
                <a:ea typeface="Aptos"/>
                <a:cs typeface="Times New Roman"/>
              </a:rPr>
              <a:t>dL</a:t>
            </a:r>
            <a:r>
              <a:rPr lang="es-ES" sz="900" kern="100" dirty="0">
                <a:latin typeface="Times New Roman"/>
                <a:ea typeface="Aptos"/>
                <a:cs typeface="Times New Roman"/>
              </a:rPr>
              <a:t>, </a:t>
            </a:r>
            <a:r>
              <a:rPr lang="es-ES" sz="900" kern="100" dirty="0" err="1">
                <a:latin typeface="Times New Roman"/>
                <a:ea typeface="Aptos"/>
                <a:cs typeface="Times New Roman"/>
              </a:rPr>
              <a:t>ferritin</a:t>
            </a:r>
            <a:r>
              <a:rPr lang="es-ES" sz="900" kern="100" dirty="0">
                <a:latin typeface="Times New Roman"/>
                <a:ea typeface="Aptos"/>
                <a:cs typeface="Times New Roman"/>
              </a:rPr>
              <a:t> </a:t>
            </a:r>
            <a:r>
              <a:rPr lang="es-ES" sz="900" kern="100" dirty="0">
                <a:latin typeface="Times New Roman" panose="02020603050405020304" pitchFamily="18" charset="0"/>
                <a:ea typeface="Aptos"/>
                <a:cs typeface="Times New Roman" panose="02020603050405020304" pitchFamily="18" charset="0"/>
              </a:rPr>
              <a:t>3</a:t>
            </a:r>
            <a:r>
              <a:rPr lang="es-ES" sz="9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0-400 </a:t>
            </a:r>
            <a:r>
              <a:rPr lang="es-ES" sz="900" kern="100" dirty="0">
                <a:latin typeface="Times New Roman"/>
                <a:ea typeface="Aptos"/>
                <a:cs typeface="Times New Roman"/>
              </a:rPr>
              <a:t>ng/ml, </a:t>
            </a:r>
            <a:r>
              <a:rPr lang="es-ES" sz="900" kern="100" dirty="0" err="1">
                <a:latin typeface="Times New Roman"/>
                <a:ea typeface="Aptos"/>
                <a:cs typeface="Times New Roman"/>
              </a:rPr>
              <a:t>transferrin</a:t>
            </a:r>
            <a:r>
              <a:rPr lang="es-ES" sz="900" kern="100" dirty="0">
                <a:latin typeface="Times New Roman"/>
                <a:ea typeface="Aptos"/>
                <a:cs typeface="Times New Roman"/>
              </a:rPr>
              <a:t> 200-360mg/</a:t>
            </a:r>
            <a:r>
              <a:rPr lang="es-ES" sz="900" kern="100" dirty="0" err="1">
                <a:latin typeface="Times New Roman"/>
                <a:ea typeface="Aptos"/>
                <a:cs typeface="Times New Roman"/>
              </a:rPr>
              <a:t>dL</a:t>
            </a:r>
            <a:r>
              <a:rPr lang="es-ES" sz="900" kern="100" dirty="0">
                <a:latin typeface="Times New Roman"/>
                <a:ea typeface="Aptos"/>
                <a:cs typeface="Times New Roman"/>
              </a:rPr>
              <a:t>, IST 24-40%, </a:t>
            </a:r>
            <a:r>
              <a:rPr lang="es-ES" sz="900" kern="100" dirty="0" err="1">
                <a:latin typeface="Times New Roman"/>
                <a:ea typeface="Aptos"/>
                <a:cs typeface="Times New Roman"/>
              </a:rPr>
              <a:t>hepcidine</a:t>
            </a:r>
            <a:r>
              <a:rPr lang="es-ES" sz="900" kern="100" dirty="0">
                <a:latin typeface="Times New Roman"/>
                <a:ea typeface="Aptos"/>
                <a:cs typeface="Times New Roman"/>
              </a:rPr>
              <a:t> 16.45 ng/</a:t>
            </a:r>
            <a:r>
              <a:rPr lang="es-ES" sz="900" kern="100" dirty="0" err="1">
                <a:latin typeface="Times New Roman"/>
                <a:ea typeface="Aptos"/>
                <a:cs typeface="Times New Roman"/>
              </a:rPr>
              <a:t>mL</a:t>
            </a:r>
            <a:endParaRPr lang="es-ES" sz="900" kern="100" dirty="0">
              <a:effectLst/>
              <a:latin typeface="Aptos"/>
              <a:ea typeface="Aptos"/>
              <a:cs typeface="Times New Roman"/>
            </a:endParaRPr>
          </a:p>
          <a:p>
            <a:pPr>
              <a:lnSpc>
                <a:spcPct val="115000"/>
              </a:lnSpc>
              <a:spcAft>
                <a:spcPts val="800"/>
              </a:spcAft>
            </a:pPr>
            <a:endParaRPr lang="es-ES" sz="1200" kern="100" dirty="0">
              <a:effectLst/>
              <a:latin typeface="Aptos"/>
              <a:ea typeface="Aptos"/>
              <a:cs typeface="Times New Roman"/>
            </a:endParaRPr>
          </a:p>
          <a:p>
            <a:pPr>
              <a:lnSpc>
                <a:spcPct val="115000"/>
              </a:lnSpc>
              <a:spcAft>
                <a:spcPts val="800"/>
              </a:spcAft>
            </a:pPr>
            <a:r>
              <a:rPr lang="es-ES" sz="900" b="1" kern="100" dirty="0">
                <a:effectLst/>
                <a:latin typeface="Times New Roman"/>
                <a:ea typeface="Aptos"/>
                <a:cs typeface="Times New Roman"/>
              </a:rPr>
              <a:t> </a:t>
            </a:r>
            <a:endParaRPr lang="es-ES" sz="1200" kern="100" dirty="0">
              <a:effectLst/>
              <a:latin typeface="Aptos"/>
              <a:ea typeface="Aptos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4942656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upo 8">
            <a:extLst>
              <a:ext uri="{FF2B5EF4-FFF2-40B4-BE49-F238E27FC236}">
                <a16:creationId xmlns:a16="http://schemas.microsoft.com/office/drawing/2014/main" id="{9AB5134F-066E-6C40-2318-9A1BC2596B95}"/>
              </a:ext>
            </a:extLst>
          </p:cNvPr>
          <p:cNvGrpSpPr/>
          <p:nvPr/>
        </p:nvGrpSpPr>
        <p:grpSpPr>
          <a:xfrm>
            <a:off x="854710" y="332656"/>
            <a:ext cx="7434580" cy="5992546"/>
            <a:chOff x="0" y="0"/>
            <a:chExt cx="7435125" cy="5992586"/>
          </a:xfrm>
        </p:grpSpPr>
        <p:pic>
          <p:nvPicPr>
            <p:cNvPr id="10" name="Picture 4">
              <a:extLst>
                <a:ext uri="{FF2B5EF4-FFF2-40B4-BE49-F238E27FC236}">
                  <a16:creationId xmlns:a16="http://schemas.microsoft.com/office/drawing/2014/main" id="{14C5DACC-7618-7A32-6A6B-34D3E4FD7CA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7972" y="87086"/>
              <a:ext cx="3365500" cy="2409190"/>
            </a:xfrm>
            <a:prstGeom prst="rect">
              <a:avLst/>
            </a:prstGeom>
            <a:noFill/>
          </p:spPr>
        </p:pic>
        <p:pic>
          <p:nvPicPr>
            <p:cNvPr id="11" name="3 Imagen" descr="Imagen que contiene Gráfico&#10;&#10;Descripción generada automáticamente">
              <a:extLst>
                <a:ext uri="{FF2B5EF4-FFF2-40B4-BE49-F238E27FC236}">
                  <a16:creationId xmlns:a16="http://schemas.microsoft.com/office/drawing/2014/main" id="{1DB41586-1211-43AE-C403-674A6CE36358}"/>
                </a:ext>
              </a:extLst>
            </p:cNvPr>
            <p:cNvPicPr/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722915" y="0"/>
              <a:ext cx="3651250" cy="268605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2" name="5 Imagen" descr="Gráfico, Gráfico de dispersión&#10;&#10;Descripción generada automáticamente">
              <a:extLst>
                <a:ext uri="{FF2B5EF4-FFF2-40B4-BE49-F238E27FC236}">
                  <a16:creationId xmlns:a16="http://schemas.microsoft.com/office/drawing/2014/main" id="{E02C2007-7040-FACC-8FB8-DDAACD9A5E99}"/>
                </a:ext>
              </a:extLst>
            </p:cNvPr>
            <p:cNvPicPr/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0" y="3592286"/>
              <a:ext cx="3727450" cy="2400300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3" name="Picture 3">
              <a:extLst>
                <a:ext uri="{FF2B5EF4-FFF2-40B4-BE49-F238E27FC236}">
                  <a16:creationId xmlns:a16="http://schemas.microsoft.com/office/drawing/2014/main" id="{36DA4171-DE1B-137B-D8C7-568BCBE2F40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722915" y="3494314"/>
              <a:ext cx="3712210" cy="2495550"/>
            </a:xfrm>
            <a:prstGeom prst="rect">
              <a:avLst/>
            </a:prstGeom>
            <a:noFill/>
          </p:spPr>
        </p:pic>
      </p:grpSp>
      <p:sp>
        <p:nvSpPr>
          <p:cNvPr id="2" name="CuadroTexto 1">
            <a:extLst>
              <a:ext uri="{FF2B5EF4-FFF2-40B4-BE49-F238E27FC236}">
                <a16:creationId xmlns:a16="http://schemas.microsoft.com/office/drawing/2014/main" id="{6D27CA7F-02CB-32BF-009F-8DA66A883457}"/>
              </a:ext>
            </a:extLst>
          </p:cNvPr>
          <p:cNvSpPr txBox="1"/>
          <p:nvPr/>
        </p:nvSpPr>
        <p:spPr>
          <a:xfrm>
            <a:off x="7460014" y="6322480"/>
            <a:ext cx="16456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 err="1"/>
              <a:t>Supp</a:t>
            </a:r>
            <a:r>
              <a:rPr lang="es-ES" b="1" dirty="0"/>
              <a:t>. Figure S1</a:t>
            </a:r>
          </a:p>
        </p:txBody>
      </p:sp>
    </p:spTree>
    <p:extLst>
      <p:ext uri="{BB962C8B-B14F-4D97-AF65-F5344CB8AC3E}">
        <p14:creationId xmlns:p14="http://schemas.microsoft.com/office/powerpoint/2010/main" val="389744523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uadroTexto 2">
            <a:extLst>
              <a:ext uri="{FF2B5EF4-FFF2-40B4-BE49-F238E27FC236}">
                <a16:creationId xmlns:a16="http://schemas.microsoft.com/office/drawing/2014/main" id="{FECB60C2-E843-B717-06B5-0ECBB7F6F873}"/>
              </a:ext>
            </a:extLst>
          </p:cNvPr>
          <p:cNvSpPr txBox="1"/>
          <p:nvPr/>
        </p:nvSpPr>
        <p:spPr>
          <a:xfrm>
            <a:off x="233772" y="980728"/>
            <a:ext cx="8676456" cy="264072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800"/>
              </a:spcAft>
            </a:pPr>
            <a:r>
              <a:rPr lang="en-US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Supplementary figure S1. A: PCA of all samples with respect to the controls.</a:t>
            </a:r>
          </a:p>
          <a:p>
            <a:pPr algn="just">
              <a:lnSpc>
                <a:spcPct val="115000"/>
              </a:lnSpc>
              <a:spcAft>
                <a:spcPts val="800"/>
              </a:spcAft>
            </a:pPr>
            <a:r>
              <a:rPr lang="en-US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PCA analysis shows the differences in data dispersion between the control group and patients with transfusion-dependent anemia. </a:t>
            </a:r>
            <a:r>
              <a:rPr lang="en-US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B: 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PCA analysis shows the differences in data dispersion between the control group and non-transfusion-dependent patients. </a:t>
            </a:r>
            <a:r>
              <a:rPr lang="en-US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C: 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PCA analysis shows the differences in data dispersion between the control and SCD patient groups. </a:t>
            </a:r>
            <a:r>
              <a:rPr lang="en-US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D: </a:t>
            </a:r>
            <a:r>
              <a:rPr lang="en-US" sz="18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Aptos" panose="020B0004020202020204" pitchFamily="34" charset="0"/>
              </a:rPr>
              <a:t>PCA analysis shows the differences in data dispersion between controls and patient with CSA. </a:t>
            </a:r>
            <a:r>
              <a:rPr lang="es-ES" sz="3200" kern="100" dirty="0">
                <a:solidFill>
                  <a:srgbClr val="000000"/>
                </a:solidFill>
                <a:effectLst/>
                <a:latin typeface="Aptos" panose="020B0004020202020204" pitchFamily="34" charset="0"/>
                <a:ea typeface="Aptos" panose="020B0004020202020204" pitchFamily="34" charset="0"/>
              </a:rPr>
              <a:t> </a:t>
            </a:r>
            <a:endParaRPr lang="es-ES" sz="3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7845704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97</TotalTime>
  <Words>292</Words>
  <Application>Microsoft Office PowerPoint</Application>
  <PresentationFormat>On-screen Show (4:3)</PresentationFormat>
  <Paragraphs>15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ptos</vt:lpstr>
      <vt:lpstr>Arial</vt:lpstr>
      <vt:lpstr>Calibri</vt:lpstr>
      <vt:lpstr>Times New Roman</vt:lpstr>
      <vt:lpstr>Tema de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quitarla32@outlook.es</dc:creator>
  <cp:lastModifiedBy>MDPI</cp:lastModifiedBy>
  <cp:revision>38</cp:revision>
  <dcterms:created xsi:type="dcterms:W3CDTF">2024-06-19T16:01:37Z</dcterms:created>
  <dcterms:modified xsi:type="dcterms:W3CDTF">2024-10-29T02:41:44Z</dcterms:modified>
</cp:coreProperties>
</file>